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5" r:id="rId2"/>
    <p:sldId id="280" r:id="rId3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0371EC-3683-4FD6-A62C-F0768B3AA7F0}" v="22" dt="2023-09-19T16:05:48.06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2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EE0371EC-3683-4FD6-A62C-F0768B3AA7F0}"/>
    <pc:docChg chg="undo custSel delSld modSld">
      <pc:chgData name="Chakraborty, Anirban" userId="beb374dd-c17a-4851-a293-48dd327a1c1a" providerId="ADAL" clId="{EE0371EC-3683-4FD6-A62C-F0768B3AA7F0}" dt="2023-09-19T16:05:48.059" v="35" actId="478"/>
      <pc:docMkLst>
        <pc:docMk/>
      </pc:docMkLst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1499400212" sldId="270"/>
        </pc:sldMkLst>
      </pc:sldChg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1362357393" sldId="271"/>
        </pc:sldMkLst>
      </pc:sldChg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3109744734" sldId="272"/>
        </pc:sldMkLst>
      </pc:sldChg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3096922174" sldId="274"/>
        </pc:sldMkLst>
      </pc:sldChg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2573754816" sldId="276"/>
        </pc:sldMkLst>
      </pc:sldChg>
      <pc:sldChg chg="del">
        <pc:chgData name="Chakraborty, Anirban" userId="beb374dd-c17a-4851-a293-48dd327a1c1a" providerId="ADAL" clId="{EE0371EC-3683-4FD6-A62C-F0768B3AA7F0}" dt="2023-09-19T13:20:03.617" v="0" actId="47"/>
        <pc:sldMkLst>
          <pc:docMk/>
          <pc:sldMk cId="550479794" sldId="278"/>
        </pc:sldMkLst>
      </pc:sldChg>
      <pc:sldChg chg="del">
        <pc:chgData name="Chakraborty, Anirban" userId="beb374dd-c17a-4851-a293-48dd327a1c1a" providerId="ADAL" clId="{EE0371EC-3683-4FD6-A62C-F0768B3AA7F0}" dt="2023-09-19T13:20:06.624" v="1" actId="47"/>
        <pc:sldMkLst>
          <pc:docMk/>
          <pc:sldMk cId="3002076954" sldId="279"/>
        </pc:sldMkLst>
      </pc:sldChg>
      <pc:sldChg chg="addSp delSp modSp mod">
        <pc:chgData name="Chakraborty, Anirban" userId="beb374dd-c17a-4851-a293-48dd327a1c1a" providerId="ADAL" clId="{EE0371EC-3683-4FD6-A62C-F0768B3AA7F0}" dt="2023-09-19T16:05:48.059" v="35" actId="478"/>
        <pc:sldMkLst>
          <pc:docMk/>
          <pc:sldMk cId="3852428335" sldId="280"/>
        </pc:sldMkLst>
        <pc:spChg chg="mod">
          <ac:chgData name="Chakraborty, Anirban" userId="beb374dd-c17a-4851-a293-48dd327a1c1a" providerId="ADAL" clId="{EE0371EC-3683-4FD6-A62C-F0768B3AA7F0}" dt="2023-09-19T13:21:01.027" v="9" actId="20577"/>
          <ac:spMkLst>
            <pc:docMk/>
            <pc:sldMk cId="3852428335" sldId="280"/>
            <ac:spMk id="8" creationId="{00000000-0000-0000-0000-000000000000}"/>
          </ac:spMkLst>
        </pc:spChg>
        <pc:spChg chg="mod ord">
          <ac:chgData name="Chakraborty, Anirban" userId="beb374dd-c17a-4851-a293-48dd327a1c1a" providerId="ADAL" clId="{EE0371EC-3683-4FD6-A62C-F0768B3AA7F0}" dt="2023-09-19T16:05:44.188" v="33" actId="166"/>
          <ac:spMkLst>
            <pc:docMk/>
            <pc:sldMk cId="3852428335" sldId="280"/>
            <ac:spMk id="69" creationId="{00000000-0000-0000-0000-000000000000}"/>
          </ac:spMkLst>
        </pc:spChg>
        <pc:picChg chg="add del mod">
          <ac:chgData name="Chakraborty, Anirban" userId="beb374dd-c17a-4851-a293-48dd327a1c1a" providerId="ADAL" clId="{EE0371EC-3683-4FD6-A62C-F0768B3AA7F0}" dt="2023-09-19T16:05:48.059" v="35" actId="478"/>
          <ac:picMkLst>
            <pc:docMk/>
            <pc:sldMk cId="3852428335" sldId="280"/>
            <ac:picMk id="3" creationId="{8E32C1CC-6FE6-5C43-EFCB-1A17F65CEC8D}"/>
          </ac:picMkLst>
        </pc:picChg>
        <pc:picChg chg="add del">
          <ac:chgData name="Chakraborty, Anirban" userId="beb374dd-c17a-4851-a293-48dd327a1c1a" providerId="ADAL" clId="{EE0371EC-3683-4FD6-A62C-F0768B3AA7F0}" dt="2023-09-19T16:05:44.640" v="34" actId="478"/>
          <ac:picMkLst>
            <pc:docMk/>
            <pc:sldMk cId="3852428335" sldId="280"/>
            <ac:picMk id="74" creationId="{00000000-0000-0000-0000-000000000000}"/>
          </ac:picMkLst>
        </pc:picChg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1026364918" sldId="281"/>
        </pc:sldMkLst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2329365240" sldId="282"/>
        </pc:sldMkLst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438658365" sldId="284"/>
        </pc:sldMkLst>
      </pc:sldChg>
      <pc:sldChg chg="modSp mod setBg">
        <pc:chgData name="Chakraborty, Anirban" userId="beb374dd-c17a-4851-a293-48dd327a1c1a" providerId="ADAL" clId="{EE0371EC-3683-4FD6-A62C-F0768B3AA7F0}" dt="2023-09-19T16:05:19.269" v="25"/>
        <pc:sldMkLst>
          <pc:docMk/>
          <pc:sldMk cId="1305156795" sldId="285"/>
        </pc:sldMkLst>
        <pc:spChg chg="mod">
          <ac:chgData name="Chakraborty, Anirban" userId="beb374dd-c17a-4851-a293-48dd327a1c1a" providerId="ADAL" clId="{EE0371EC-3683-4FD6-A62C-F0768B3AA7F0}" dt="2023-09-19T13:20:56.888" v="6" actId="14100"/>
          <ac:spMkLst>
            <pc:docMk/>
            <pc:sldMk cId="1305156795" sldId="285"/>
            <ac:spMk id="5" creationId="{00000000-0000-0000-0000-000000000000}"/>
          </ac:spMkLst>
        </pc:spChg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4028044274" sldId="286"/>
        </pc:sldMkLst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256142667" sldId="287"/>
        </pc:sldMkLst>
      </pc:sldChg>
      <pc:sldChg chg="del">
        <pc:chgData name="Chakraborty, Anirban" userId="beb374dd-c17a-4851-a293-48dd327a1c1a" providerId="ADAL" clId="{EE0371EC-3683-4FD6-A62C-F0768B3AA7F0}" dt="2023-09-19T13:20:43.015" v="2" actId="47"/>
        <pc:sldMkLst>
          <pc:docMk/>
          <pc:sldMk cId="3421195017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8723" y="771525"/>
            <a:ext cx="5708904" cy="485203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86425" y="66675"/>
            <a:ext cx="999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3A-B</a:t>
            </a:r>
          </a:p>
        </p:txBody>
      </p:sp>
      <p:sp>
        <p:nvSpPr>
          <p:cNvPr id="6" name="Rectangle 5"/>
          <p:cNvSpPr/>
          <p:nvPr/>
        </p:nvSpPr>
        <p:spPr>
          <a:xfrm>
            <a:off x="2990849" y="1905000"/>
            <a:ext cx="6829425" cy="41433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156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ight Triangle 4"/>
          <p:cNvSpPr/>
          <p:nvPr/>
        </p:nvSpPr>
        <p:spPr bwMode="auto">
          <a:xfrm>
            <a:off x="2244597" y="2477053"/>
            <a:ext cx="1741044" cy="381208"/>
          </a:xfrm>
          <a:prstGeom prst="rtTriangle">
            <a:avLst/>
          </a:prstGeom>
          <a:noFill/>
          <a:ln w="12700">
            <a:solidFill>
              <a:schemeClr val="tx1"/>
            </a:solidFill>
          </a:ln>
          <a:scene3d>
            <a:camera prst="orthographicFront">
              <a:rot lat="0" lon="1080000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900" dirty="0"/>
          </a:p>
        </p:txBody>
      </p:sp>
      <p:sp>
        <p:nvSpPr>
          <p:cNvPr id="6" name="TextBox 22"/>
          <p:cNvSpPr txBox="1">
            <a:spLocks noChangeArrowheads="1"/>
          </p:cNvSpPr>
          <p:nvPr/>
        </p:nvSpPr>
        <p:spPr bwMode="auto">
          <a:xfrm>
            <a:off x="2971800" y="2657566"/>
            <a:ext cx="11176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 Black" panose="020B0A04020102020204" pitchFamily="34" charset="0"/>
              </a:rPr>
              <a:t>Q29 (f moles)</a:t>
            </a:r>
          </a:p>
        </p:txBody>
      </p:sp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561975" y="2724241"/>
            <a:ext cx="403860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 Black" panose="020B0A04020102020204" pitchFamily="34" charset="0"/>
              </a:rPr>
              <a:t>     PNKP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 Black" panose="020B0A04020102020204" pitchFamily="34" charset="0"/>
              </a:rPr>
              <a:t>(50 </a:t>
            </a:r>
            <a:r>
              <a:rPr lang="en-US" altLang="en-US" sz="1000" dirty="0" err="1">
                <a:latin typeface="Arial Black" panose="020B0A04020102020204" pitchFamily="34" charset="0"/>
              </a:rPr>
              <a:t>fmoles</a:t>
            </a:r>
            <a:r>
              <a:rPr lang="en-US" altLang="en-US" sz="1000" dirty="0">
                <a:latin typeface="Arial Black" panose="020B0A04020102020204" pitchFamily="34" charset="0"/>
              </a:rPr>
              <a:t>)       -      +      +      +      +      +      +      -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48225" y="72490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3A-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39416" y="2046649"/>
            <a:ext cx="15462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-50-100-200-400</a:t>
            </a:r>
            <a:r>
              <a:rPr lang="en-US" dirty="0"/>
              <a:t> </a:t>
            </a:r>
            <a:r>
              <a:rPr lang="en-US" sz="1200" dirty="0" err="1"/>
              <a:t>fmoles</a:t>
            </a:r>
            <a:endParaRPr lang="en-US" dirty="0"/>
          </a:p>
        </p:txBody>
      </p:sp>
      <p:sp>
        <p:nvSpPr>
          <p:cNvPr id="10" name="TextBox 16"/>
          <p:cNvSpPr txBox="1">
            <a:spLocks noChangeArrowheads="1"/>
          </p:cNvSpPr>
          <p:nvPr/>
        </p:nvSpPr>
        <p:spPr bwMode="auto">
          <a:xfrm>
            <a:off x="225297" y="2537546"/>
            <a:ext cx="4038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 Black" panose="020B0A04020102020204" pitchFamily="34" charset="0"/>
              </a:rPr>
              <a:t>     ATXN3-Q29         -       -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029075" y="2471654"/>
            <a:ext cx="295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+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981075" y="3505291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33425" y="3305266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42950" y="4238716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P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1000125" y="4400641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61975" y="1876516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3602057" y="1830836"/>
            <a:ext cx="1117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mol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"/>
          <p:cNvSpPr txBox="1">
            <a:spLocks noChangeArrowheads="1"/>
          </p:cNvSpPr>
          <p:nvPr/>
        </p:nvSpPr>
        <p:spPr bwMode="auto">
          <a:xfrm>
            <a:off x="1274696" y="2949493"/>
            <a:ext cx="3192529" cy="279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dirty="0">
                <a:latin typeface="Arial" panose="020B0604020202020204" pitchFamily="34" charset="0"/>
              </a:rPr>
              <a:t>        </a:t>
            </a:r>
            <a:r>
              <a:rPr lang="en-US" altLang="en-US" sz="1000" dirty="0">
                <a:latin typeface="Arial" panose="020B0604020202020204" pitchFamily="34" charset="0"/>
              </a:rPr>
              <a:t>1       2        3        4        5        6       7       8   </a:t>
            </a:r>
          </a:p>
        </p:txBody>
      </p:sp>
      <p:sp>
        <p:nvSpPr>
          <p:cNvPr id="54" name="TextBox 53"/>
          <p:cNvSpPr txBox="1">
            <a:spLocks noChangeArrowheads="1"/>
          </p:cNvSpPr>
          <p:nvPr/>
        </p:nvSpPr>
        <p:spPr bwMode="auto">
          <a:xfrm>
            <a:off x="7516031" y="2482374"/>
            <a:ext cx="35083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dirty="0">
                <a:latin typeface="Arial" panose="020B0604020202020204" pitchFamily="34" charset="0"/>
              </a:rPr>
              <a:t> PNKP(50 </a:t>
            </a:r>
            <a:r>
              <a:rPr lang="en-US" altLang="en-US" sz="1200" dirty="0" err="1">
                <a:latin typeface="Arial" panose="020B0604020202020204" pitchFamily="34" charset="0"/>
              </a:rPr>
              <a:t>fmoles</a:t>
            </a:r>
            <a:r>
              <a:rPr lang="en-US" altLang="en-US" sz="1200" dirty="0">
                <a:latin typeface="Arial" panose="020B0604020202020204" pitchFamily="34" charset="0"/>
              </a:rPr>
              <a:t>)     -       +      -      +      +      + </a:t>
            </a:r>
          </a:p>
        </p:txBody>
      </p:sp>
      <p:sp>
        <p:nvSpPr>
          <p:cNvPr id="55" name="TextBox 3"/>
          <p:cNvSpPr txBox="1">
            <a:spLocks noChangeArrowheads="1"/>
          </p:cNvSpPr>
          <p:nvPr/>
        </p:nvSpPr>
        <p:spPr bwMode="auto">
          <a:xfrm>
            <a:off x="8555844" y="2688749"/>
            <a:ext cx="25987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dirty="0">
                <a:latin typeface="Arial" panose="020B0604020202020204" pitchFamily="34" charset="0"/>
              </a:rPr>
              <a:t>        1       2      3      4      5      6     </a:t>
            </a:r>
          </a:p>
        </p:txBody>
      </p:sp>
      <p:sp>
        <p:nvSpPr>
          <p:cNvPr id="56" name="TextBox 8"/>
          <p:cNvSpPr txBox="1">
            <a:spLocks noChangeArrowheads="1"/>
          </p:cNvSpPr>
          <p:nvPr/>
        </p:nvSpPr>
        <p:spPr bwMode="auto">
          <a:xfrm>
            <a:off x="8268506" y="2053749"/>
            <a:ext cx="668338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>
                <a:latin typeface="Arial" panose="020B0604020202020204" pitchFamily="34" charset="0"/>
              </a:rPr>
              <a:t>ATXN3</a:t>
            </a:r>
          </a:p>
          <a:p>
            <a:r>
              <a:rPr lang="en-US" altLang="en-US" sz="1200">
                <a:latin typeface="Arial" panose="020B0604020202020204" pitchFamily="34" charset="0"/>
              </a:rPr>
              <a:t> (Q72)</a:t>
            </a:r>
          </a:p>
        </p:txBody>
      </p:sp>
      <p:grpSp>
        <p:nvGrpSpPr>
          <p:cNvPr id="57" name="Group 30"/>
          <p:cNvGrpSpPr>
            <a:grpSpLocks/>
          </p:cNvGrpSpPr>
          <p:nvPr/>
        </p:nvGrpSpPr>
        <p:grpSpPr bwMode="auto">
          <a:xfrm>
            <a:off x="8811431" y="2160112"/>
            <a:ext cx="1971675" cy="282575"/>
            <a:chOff x="5166157" y="1789112"/>
            <a:chExt cx="1973188" cy="283457"/>
          </a:xfrm>
        </p:grpSpPr>
        <p:sp>
          <p:nvSpPr>
            <p:cNvPr id="58" name="Right Triangle 57"/>
            <p:cNvSpPr/>
            <p:nvPr/>
          </p:nvSpPr>
          <p:spPr>
            <a:xfrm flipH="1">
              <a:off x="6413301" y="1789112"/>
              <a:ext cx="726044" cy="152876"/>
            </a:xfrm>
            <a:prstGeom prst="rtTriangl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sp>
          <p:nvSpPr>
            <p:cNvPr id="59" name="TextBox 24"/>
            <p:cNvSpPr txBox="1">
              <a:spLocks noChangeArrowheads="1"/>
            </p:cNvSpPr>
            <p:nvPr/>
          </p:nvSpPr>
          <p:spPr bwMode="auto">
            <a:xfrm>
              <a:off x="5788693" y="1792288"/>
              <a:ext cx="540948" cy="2774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en-US" sz="1200">
                  <a:latin typeface="Arial" panose="020B0604020202020204" pitchFamily="34" charset="0"/>
                </a:rPr>
                <a:t>  +++</a:t>
              </a:r>
            </a:p>
          </p:txBody>
        </p:sp>
        <p:sp>
          <p:nvSpPr>
            <p:cNvPr id="60" name="TextBox 28"/>
            <p:cNvSpPr txBox="1">
              <a:spLocks noChangeArrowheads="1"/>
            </p:cNvSpPr>
            <p:nvPr/>
          </p:nvSpPr>
          <p:spPr bwMode="auto">
            <a:xfrm>
              <a:off x="5166157" y="1795134"/>
              <a:ext cx="366087" cy="277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en-US" sz="1200">
                  <a:latin typeface="Arial" panose="020B0604020202020204" pitchFamily="34" charset="0"/>
                </a:rPr>
                <a:t>   -</a:t>
              </a:r>
            </a:p>
          </p:txBody>
        </p:sp>
        <p:sp>
          <p:nvSpPr>
            <p:cNvPr id="61" name="TextBox 29"/>
            <p:cNvSpPr txBox="1">
              <a:spLocks noChangeArrowheads="1"/>
            </p:cNvSpPr>
            <p:nvPr/>
          </p:nvSpPr>
          <p:spPr bwMode="auto">
            <a:xfrm>
              <a:off x="5544605" y="1795134"/>
              <a:ext cx="366087" cy="277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US" altLang="en-US" sz="1200">
                  <a:latin typeface="Arial" panose="020B0604020202020204" pitchFamily="34" charset="0"/>
                </a:rPr>
                <a:t>   -</a:t>
              </a:r>
            </a:p>
          </p:txBody>
        </p:sp>
      </p:grpSp>
      <p:cxnSp>
        <p:nvCxnSpPr>
          <p:cNvPr id="63" name="Straight Arrow Connector 62"/>
          <p:cNvCxnSpPr/>
          <p:nvPr/>
        </p:nvCxnSpPr>
        <p:spPr>
          <a:xfrm>
            <a:off x="8430431" y="3130074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8182781" y="2930049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8182781" y="4282599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P</a:t>
            </a:r>
          </a:p>
        </p:txBody>
      </p:sp>
      <p:cxnSp>
        <p:nvCxnSpPr>
          <p:cNvPr id="66" name="Straight Arrow Connector 65"/>
          <p:cNvCxnSpPr/>
          <p:nvPr/>
        </p:nvCxnSpPr>
        <p:spPr>
          <a:xfrm>
            <a:off x="8439956" y="4444524"/>
            <a:ext cx="3619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9974023" y="1779164"/>
            <a:ext cx="1546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0-100-200</a:t>
            </a:r>
            <a:r>
              <a:rPr lang="en-US" dirty="0"/>
              <a:t> </a:t>
            </a:r>
            <a:r>
              <a:rPr lang="en-US" sz="1200" dirty="0" err="1"/>
              <a:t>fmoles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>
            <a:off x="7622394" y="1788689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0012384" y="4578974"/>
            <a:ext cx="180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8994334" y="1704050"/>
            <a:ext cx="15462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00</a:t>
            </a:r>
            <a:r>
              <a:rPr lang="en-US" dirty="0"/>
              <a:t> </a:t>
            </a:r>
          </a:p>
          <a:p>
            <a:pPr algn="ctr"/>
            <a:r>
              <a:rPr lang="en-US" sz="1200" dirty="0" err="1"/>
              <a:t>fmoles</a:t>
            </a:r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0650" y="3173443"/>
            <a:ext cx="3084843" cy="1639966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1520129" y="3347996"/>
            <a:ext cx="2804221" cy="13694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3387741" y="4700493"/>
            <a:ext cx="180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pic>
        <p:nvPicPr>
          <p:cNvPr id="74" name="Picture 6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85"/>
          <a:stretch>
            <a:fillRect/>
          </a:stretch>
        </p:blipFill>
        <p:spPr bwMode="auto">
          <a:xfrm>
            <a:off x="8894598" y="2991802"/>
            <a:ext cx="2003425" cy="158717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9" name="Rectangle 68"/>
          <p:cNvSpPr/>
          <p:nvPr/>
        </p:nvSpPr>
        <p:spPr>
          <a:xfrm>
            <a:off x="8876519" y="3004689"/>
            <a:ext cx="2003425" cy="15474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428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63</TotalTime>
  <Words>87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Black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Chakraborty, Anirban</cp:lastModifiedBy>
  <cp:revision>150</cp:revision>
  <cp:lastPrinted>2023-08-29T23:30:28Z</cp:lastPrinted>
  <dcterms:created xsi:type="dcterms:W3CDTF">2021-02-24T12:59:59Z</dcterms:created>
  <dcterms:modified xsi:type="dcterms:W3CDTF">2023-09-19T16:05:49Z</dcterms:modified>
</cp:coreProperties>
</file>